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7D2F45B-EF11-42F4-B41A-B90F393D7136}" v="9" dt="2026-04-23T15:07:39.27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21" autoAdjust="0"/>
    <p:restoredTop sz="94660"/>
  </p:normalViewPr>
  <p:slideViewPr>
    <p:cSldViewPr snapToGrid="0">
      <p:cViewPr varScale="1">
        <p:scale>
          <a:sx n="147" d="100"/>
          <a:sy n="147" d="100"/>
        </p:scale>
        <p:origin x="73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en, Qun   RICVAMC" userId="11d5c42c-86f1-457a-a77a-81c5437f2bd1" providerId="ADAL" clId="{6DD0D98C-78EC-4E37-81AD-09B5A1FCD72D}"/>
    <pc:docChg chg="custSel modSld">
      <pc:chgData name="Chen, Qun   RICVAMC" userId="11d5c42c-86f1-457a-a77a-81c5437f2bd1" providerId="ADAL" clId="{6DD0D98C-78EC-4E37-81AD-09B5A1FCD72D}" dt="2026-04-23T15:07:44.450" v="224" actId="1076"/>
      <pc:docMkLst>
        <pc:docMk/>
      </pc:docMkLst>
      <pc:sldChg chg="addSp modSp mod">
        <pc:chgData name="Chen, Qun   RICVAMC" userId="11d5c42c-86f1-457a-a77a-81c5437f2bd1" providerId="ADAL" clId="{6DD0D98C-78EC-4E37-81AD-09B5A1FCD72D}" dt="2026-04-23T15:07:44.450" v="224" actId="1076"/>
        <pc:sldMkLst>
          <pc:docMk/>
          <pc:sldMk cId="3729704677" sldId="256"/>
        </pc:sldMkLst>
        <pc:spChg chg="mod">
          <ac:chgData name="Chen, Qun   RICVAMC" userId="11d5c42c-86f1-457a-a77a-81c5437f2bd1" providerId="ADAL" clId="{6DD0D98C-78EC-4E37-81AD-09B5A1FCD72D}" dt="2026-04-23T15:07:39.278" v="223" actId="1076"/>
          <ac:spMkLst>
            <pc:docMk/>
            <pc:sldMk cId="3729704677" sldId="256"/>
            <ac:spMk id="4" creationId="{86C0F00F-976E-5747-CB00-4C21AD0625AC}"/>
          </ac:spMkLst>
        </pc:spChg>
        <pc:spChg chg="add mod">
          <ac:chgData name="Chen, Qun   RICVAMC" userId="11d5c42c-86f1-457a-a77a-81c5437f2bd1" providerId="ADAL" clId="{6DD0D98C-78EC-4E37-81AD-09B5A1FCD72D}" dt="2026-04-23T15:07:21.403" v="220" actId="1076"/>
          <ac:spMkLst>
            <pc:docMk/>
            <pc:sldMk cId="3729704677" sldId="256"/>
            <ac:spMk id="7" creationId="{1206639F-566D-D575-4BF3-0B6830650163}"/>
          </ac:spMkLst>
        </pc:spChg>
        <pc:spChg chg="add mod">
          <ac:chgData name="Chen, Qun   RICVAMC" userId="11d5c42c-86f1-457a-a77a-81c5437f2bd1" providerId="ADAL" clId="{6DD0D98C-78EC-4E37-81AD-09B5A1FCD72D}" dt="2026-04-23T15:07:21.403" v="220" actId="1076"/>
          <ac:spMkLst>
            <pc:docMk/>
            <pc:sldMk cId="3729704677" sldId="256"/>
            <ac:spMk id="10" creationId="{F5810DD5-0A15-8C7B-A40E-2F50ED08BC72}"/>
          </ac:spMkLst>
        </pc:spChg>
        <pc:spChg chg="add mod">
          <ac:chgData name="Chen, Qun   RICVAMC" userId="11d5c42c-86f1-457a-a77a-81c5437f2bd1" providerId="ADAL" clId="{6DD0D98C-78EC-4E37-81AD-09B5A1FCD72D}" dt="2026-04-23T15:07:44.450" v="224" actId="1076"/>
          <ac:spMkLst>
            <pc:docMk/>
            <pc:sldMk cId="3729704677" sldId="256"/>
            <ac:spMk id="11" creationId="{6C1851F2-3FD4-5FDA-E210-EDE79D576674}"/>
          </ac:spMkLst>
        </pc:spChg>
        <pc:spChg chg="add mod">
          <ac:chgData name="Chen, Qun   RICVAMC" userId="11d5c42c-86f1-457a-a77a-81c5437f2bd1" providerId="ADAL" clId="{6DD0D98C-78EC-4E37-81AD-09B5A1FCD72D}" dt="2026-04-23T15:07:39.278" v="223" actId="1076"/>
          <ac:spMkLst>
            <pc:docMk/>
            <pc:sldMk cId="3729704677" sldId="256"/>
            <ac:spMk id="13" creationId="{A94B53D6-961E-75D5-6919-27B4500F6581}"/>
          </ac:spMkLst>
        </pc:spChg>
        <pc:spChg chg="add mod">
          <ac:chgData name="Chen, Qun   RICVAMC" userId="11d5c42c-86f1-457a-a77a-81c5437f2bd1" providerId="ADAL" clId="{6DD0D98C-78EC-4E37-81AD-09B5A1FCD72D}" dt="2026-04-23T15:07:44.450" v="224" actId="1076"/>
          <ac:spMkLst>
            <pc:docMk/>
            <pc:sldMk cId="3729704677" sldId="256"/>
            <ac:spMk id="14" creationId="{DC8EEB43-8A35-9C51-E860-E44F9F278A36}"/>
          </ac:spMkLst>
        </pc:spChg>
        <pc:spChg chg="add mod">
          <ac:chgData name="Chen, Qun   RICVAMC" userId="11d5c42c-86f1-457a-a77a-81c5437f2bd1" providerId="ADAL" clId="{6DD0D98C-78EC-4E37-81AD-09B5A1FCD72D}" dt="2026-04-23T15:07:12.465" v="219" actId="1076"/>
          <ac:spMkLst>
            <pc:docMk/>
            <pc:sldMk cId="3729704677" sldId="256"/>
            <ac:spMk id="17" creationId="{129A4E3C-CA37-B51B-7C96-828237AFED81}"/>
          </ac:spMkLst>
        </pc:spChg>
        <pc:picChg chg="add mod">
          <ac:chgData name="Chen, Qun   RICVAMC" userId="11d5c42c-86f1-457a-a77a-81c5437f2bd1" providerId="ADAL" clId="{6DD0D98C-78EC-4E37-81AD-09B5A1FCD72D}" dt="2026-04-23T15:07:44.450" v="224" actId="1076"/>
          <ac:picMkLst>
            <pc:docMk/>
            <pc:sldMk cId="3729704677" sldId="256"/>
            <ac:picMk id="3" creationId="{B23C13AD-A1D6-06F3-D966-C4FA736463FA}"/>
          </ac:picMkLst>
        </pc:picChg>
        <pc:picChg chg="add mod">
          <ac:chgData name="Chen, Qun   RICVAMC" userId="11d5c42c-86f1-457a-a77a-81c5437f2bd1" providerId="ADAL" clId="{6DD0D98C-78EC-4E37-81AD-09B5A1FCD72D}" dt="2026-04-23T15:07:39.278" v="223" actId="1076"/>
          <ac:picMkLst>
            <pc:docMk/>
            <pc:sldMk cId="3729704677" sldId="256"/>
            <ac:picMk id="6" creationId="{B8BE5221-C936-10D7-73B4-D30737C2152E}"/>
          </ac:picMkLst>
        </pc:picChg>
        <pc:picChg chg="add mod">
          <ac:chgData name="Chen, Qun   RICVAMC" userId="11d5c42c-86f1-457a-a77a-81c5437f2bd1" providerId="ADAL" clId="{6DD0D98C-78EC-4E37-81AD-09B5A1FCD72D}" dt="2026-04-23T15:07:44.450" v="224" actId="1076"/>
          <ac:picMkLst>
            <pc:docMk/>
            <pc:sldMk cId="3729704677" sldId="256"/>
            <ac:picMk id="8" creationId="{5CB9C11F-1AE0-36AB-859F-DE92FC0F39E0}"/>
          </ac:picMkLst>
        </pc:picChg>
        <pc:picChg chg="add mod">
          <ac:chgData name="Chen, Qun   RICVAMC" userId="11d5c42c-86f1-457a-a77a-81c5437f2bd1" providerId="ADAL" clId="{6DD0D98C-78EC-4E37-81AD-09B5A1FCD72D}" dt="2026-04-23T15:07:21.403" v="220" actId="1076"/>
          <ac:picMkLst>
            <pc:docMk/>
            <pc:sldMk cId="3729704677" sldId="256"/>
            <ac:picMk id="9" creationId="{EBEC9A7E-45F4-8A03-48E4-CE3633D5140D}"/>
          </ac:picMkLst>
        </pc:picChg>
        <pc:picChg chg="add mod">
          <ac:chgData name="Chen, Qun   RICVAMC" userId="11d5c42c-86f1-457a-a77a-81c5437f2bd1" providerId="ADAL" clId="{6DD0D98C-78EC-4E37-81AD-09B5A1FCD72D}" dt="2026-04-23T15:07:21.403" v="220" actId="1076"/>
          <ac:picMkLst>
            <pc:docMk/>
            <pc:sldMk cId="3729704677" sldId="256"/>
            <ac:picMk id="12" creationId="{DAAB254F-E381-2422-FEC0-B32F87523934}"/>
          </ac:picMkLst>
        </pc:picChg>
        <pc:picChg chg="add mod">
          <ac:chgData name="Chen, Qun   RICVAMC" userId="11d5c42c-86f1-457a-a77a-81c5437f2bd1" providerId="ADAL" clId="{6DD0D98C-78EC-4E37-81AD-09B5A1FCD72D}" dt="2026-04-23T15:06:35.374" v="195" actId="1076"/>
          <ac:picMkLst>
            <pc:docMk/>
            <pc:sldMk cId="3729704677" sldId="256"/>
            <ac:picMk id="16" creationId="{2595035B-E72B-AD4F-EA05-FFA01D4AD6D3}"/>
          </ac:picMkLst>
        </pc:picChg>
        <pc:picChg chg="mod">
          <ac:chgData name="Chen, Qun   RICVAMC" userId="11d5c42c-86f1-457a-a77a-81c5437f2bd1" providerId="ADAL" clId="{6DD0D98C-78EC-4E37-81AD-09B5A1FCD72D}" dt="2026-04-23T15:07:39.278" v="223" actId="1076"/>
          <ac:picMkLst>
            <pc:docMk/>
            <pc:sldMk cId="3729704677" sldId="256"/>
            <ac:picMk id="1026" creationId="{48716AAF-0266-44EE-21DE-75E502DDAE12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5F1E92-320C-46B6-8EF2-19A14603A56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9FCE416-9622-B68C-6A2E-E4C4DF6BE6B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F66163-384C-7432-1E8C-597AB3483E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90D26-1826-4DAC-8E52-354F357F58F3}" type="datetimeFigureOut">
              <a:rPr lang="en-US" smtClean="0"/>
              <a:t>4/2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D9C420-CC7C-A862-9091-08355853CB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590C8E-8EBA-A86D-0C45-2FE752FB4B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DF4CD-00BA-4A51-A430-F6FD433E8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7591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220A6A-0DAF-4222-A497-E97F57E176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33667E5-2620-45E1-F60F-BE226E273F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239019-6B94-DA8C-5CC0-4CDAB518D9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90D26-1826-4DAC-8E52-354F357F58F3}" type="datetimeFigureOut">
              <a:rPr lang="en-US" smtClean="0"/>
              <a:t>4/2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AC8C7E-42C4-6B94-D771-16ED4E3BC8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867B80-FA2E-6D3A-B698-5719C82541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DF4CD-00BA-4A51-A430-F6FD433E8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2302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FCCE136-8F35-9C3A-9034-D6A0BAC15BF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257DB7-9005-FF51-8A4D-7DF4B4A659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7D8780-BB88-A158-459A-8A9416ADB2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90D26-1826-4DAC-8E52-354F357F58F3}" type="datetimeFigureOut">
              <a:rPr lang="en-US" smtClean="0"/>
              <a:t>4/2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D18A8F-F775-A63F-6499-317C61F4A6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22F168-53C0-53A5-3F6E-996BF9FEFB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DF4CD-00BA-4A51-A430-F6FD433E8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76311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F5D621-A178-9606-D67D-C280B19160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DD124A-A340-ED41-3775-6310150637A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78BD1C-7E6E-9FF0-87B5-B572C69465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90D26-1826-4DAC-8E52-354F357F58F3}" type="datetimeFigureOut">
              <a:rPr lang="en-US" smtClean="0"/>
              <a:t>4/2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4089FE-C9A8-1C23-8921-D3DE8FFAEA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45F7B8-C975-ED53-164E-232779D7E2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DF4CD-00BA-4A51-A430-F6FD433E8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355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8F07E6-5B88-243C-49DB-928690EBFC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39396D-7C52-F373-9445-9F020D808E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2C31D3-36FA-3C65-4B07-E825BD575E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90D26-1826-4DAC-8E52-354F357F58F3}" type="datetimeFigureOut">
              <a:rPr lang="en-US" smtClean="0"/>
              <a:t>4/2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209C42-67EE-C589-1A4E-E9E6B8EB1D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4E5BA0-FC4A-E477-AF23-4FBDC07069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DF4CD-00BA-4A51-A430-F6FD433E8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19398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618648-1C35-BF97-2046-7E7727BF2F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7C6BC3-4C5E-6A05-41D5-F080F1F4D87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EE88668-BD37-80CA-954C-C7CAD9A249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5AA96F-5027-97E3-B7B3-2686337204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90D26-1826-4DAC-8E52-354F357F58F3}" type="datetimeFigureOut">
              <a:rPr lang="en-US" smtClean="0"/>
              <a:t>4/23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ADBC07-4ABA-B9A1-3E5B-7C202531C1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8F1CB4-2827-3B10-B2AD-8ADF9F19F9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DF4CD-00BA-4A51-A430-F6FD433E8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14108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91FE14-1A2C-7487-072E-AABAC6FAFC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804928-750F-4C01-2458-103BA0E6C1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610119-0834-7751-0995-D727D37C36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EE7B58D-7421-E0D3-EB9B-741F100A553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72F9B97-6C13-64AD-06EE-97F448F6A8B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8E32AB9-AD7E-9FE2-76FE-C13EDC9DF3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90D26-1826-4DAC-8E52-354F357F58F3}" type="datetimeFigureOut">
              <a:rPr lang="en-US" smtClean="0"/>
              <a:t>4/23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409F158-9D9E-7BF6-C63B-45C0015A25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9842781-B37A-E7F9-8BB4-D1EBC82D29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DF4CD-00BA-4A51-A430-F6FD433E8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626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32FAA4-DB26-3B17-D519-645C871788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F6AB8A1-9026-78EB-E569-E592287FFC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90D26-1826-4DAC-8E52-354F357F58F3}" type="datetimeFigureOut">
              <a:rPr lang="en-US" smtClean="0"/>
              <a:t>4/23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19E91CC-F086-45A1-74DA-D55904AF83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CF20CAB-218A-4083-0DCE-4429000259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DF4CD-00BA-4A51-A430-F6FD433E8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2680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FA90B1B-B4C3-31B6-54AA-E4E68C743D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90D26-1826-4DAC-8E52-354F357F58F3}" type="datetimeFigureOut">
              <a:rPr lang="en-US" smtClean="0"/>
              <a:t>4/23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64FCDC4-0E18-8ADC-1008-7977450740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FC1E1CB-7849-BD37-6C3E-C70CAB294C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DF4CD-00BA-4A51-A430-F6FD433E8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0323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C36483-9533-0285-D24C-92AF8E4A86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750F7B-793C-C3A2-5BF0-629EE468DCB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A2DC9BE-C464-4D7B-8BC4-3BDBC2FC88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EEA6D8B-7612-5AA8-05A4-49ABB45711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90D26-1826-4DAC-8E52-354F357F58F3}" type="datetimeFigureOut">
              <a:rPr lang="en-US" smtClean="0"/>
              <a:t>4/23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346EB3-08E3-E3C3-2AC4-8233F628E8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69DA45-0658-1705-CF7A-B2C57059D5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DF4CD-00BA-4A51-A430-F6FD433E8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1805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36D1B1-9561-7AEE-E0E8-2BCFEC3C05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274D588-5D1E-3D71-28BD-B5EC429ED2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E1AEEC9-591B-2E26-2220-EC5D541363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705AA2-D289-BEDF-A3C4-7BDB8AC207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90D26-1826-4DAC-8E52-354F357F58F3}" type="datetimeFigureOut">
              <a:rPr lang="en-US" smtClean="0"/>
              <a:t>4/23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36FC079-7F9E-AD5F-5D47-8220753EF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89F223-2BF1-CAE8-6F40-3BEEAF4B07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DF4CD-00BA-4A51-A430-F6FD433E8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6282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C4ED937-D0D8-B00D-DFB4-41C394EEB6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85AEEB-C936-5D26-65D5-FBCC7D313F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A111F6-9D2F-32F9-C878-47C76823712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7D90D26-1826-4DAC-8E52-354F357F58F3}" type="datetimeFigureOut">
              <a:rPr lang="en-US" smtClean="0"/>
              <a:t>4/2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3D566F-2898-3B55-BFE8-894AA5FA4B7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20B921-6ADD-48FF-9DBE-DA802AB3D56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B3DF4CD-00BA-4A51-A430-F6FD433E8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4204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>
            <a:extLst>
              <a:ext uri="{FF2B5EF4-FFF2-40B4-BE49-F238E27FC236}">
                <a16:creationId xmlns:a16="http://schemas.microsoft.com/office/drawing/2014/main" id="{48716AAF-0266-44EE-21DE-75E502DDAE1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51057" y="3355980"/>
            <a:ext cx="3384290" cy="27065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6C0F00F-976E-5747-CB00-4C21AD0625AC}"/>
              </a:ext>
            </a:extLst>
          </p:cNvPr>
          <p:cNvSpPr txBox="1"/>
          <p:nvPr/>
        </p:nvSpPr>
        <p:spPr>
          <a:xfrm>
            <a:off x="4737661" y="6096338"/>
            <a:ext cx="29231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otal protein for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y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---Figure 4 panel D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B8BE5221-C936-10D7-73B4-D30737C2152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51057" y="2667248"/>
            <a:ext cx="3384290" cy="25180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206639F-566D-D575-4BF3-0B6830650163}"/>
              </a:ext>
            </a:extLst>
          </p:cNvPr>
          <p:cNvSpPr txBox="1"/>
          <p:nvPr/>
        </p:nvSpPr>
        <p:spPr>
          <a:xfrm>
            <a:off x="771927" y="2986648"/>
            <a:ext cx="26837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mage for mitofilin—Figure 4 panel C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EBEC9A7E-45F4-8A03-48E4-CE3633D5140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728" y="3355980"/>
            <a:ext cx="3831356" cy="276083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5810DD5-0A15-8C7B-A40E-2F50ED08BC72}"/>
              </a:ext>
            </a:extLst>
          </p:cNvPr>
          <p:cNvSpPr txBox="1"/>
          <p:nvPr/>
        </p:nvSpPr>
        <p:spPr>
          <a:xfrm>
            <a:off x="771927" y="6116810"/>
            <a:ext cx="3093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otal protein for mitofilin---Figure 4 panel C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DAAB254F-E381-2422-FEC0-B32F8752393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512" y="2608486"/>
            <a:ext cx="3831356" cy="369332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A94B53D6-961E-75D5-6919-27B4500F6581}"/>
              </a:ext>
            </a:extLst>
          </p:cNvPr>
          <p:cNvSpPr txBox="1"/>
          <p:nvPr/>
        </p:nvSpPr>
        <p:spPr>
          <a:xfrm>
            <a:off x="5133446" y="2973291"/>
            <a:ext cx="2462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mage for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y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--Figure 4 panel D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23C13AD-A1D6-06F3-D966-C4FA736463F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72429" y="3678183"/>
            <a:ext cx="2975497" cy="237241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CB9C11F-1AE0-36AB-859F-DE92FC0F39E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05558" y="2762557"/>
            <a:ext cx="3020894" cy="502838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6C1851F2-3FD4-5FDA-E210-EDE79D576674}"/>
              </a:ext>
            </a:extLst>
          </p:cNvPr>
          <p:cNvSpPr txBox="1"/>
          <p:nvPr/>
        </p:nvSpPr>
        <p:spPr>
          <a:xfrm>
            <a:off x="8852682" y="3265395"/>
            <a:ext cx="23963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mage for AIF—Figure 5 panel 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C8EEB43-8A35-9C51-E860-E44F9F278A36}"/>
              </a:ext>
            </a:extLst>
          </p:cNvPr>
          <p:cNvSpPr txBox="1"/>
          <p:nvPr/>
        </p:nvSpPr>
        <p:spPr>
          <a:xfrm>
            <a:off x="8961996" y="6096338"/>
            <a:ext cx="27892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otal protein for AIF—Figure 5 panel A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2595035B-E72B-AD4F-EA05-FFA01D4AD6D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069" y="242272"/>
            <a:ext cx="3063582" cy="1363586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129A4E3C-CA37-B51B-7C96-828237AFED81}"/>
              </a:ext>
            </a:extLst>
          </p:cNvPr>
          <p:cNvSpPr txBox="1"/>
          <p:nvPr/>
        </p:nvSpPr>
        <p:spPr>
          <a:xfrm>
            <a:off x="479866" y="1757720"/>
            <a:ext cx="28119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mage for mitofilin cleavage —Figure 1</a:t>
            </a:r>
          </a:p>
        </p:txBody>
      </p:sp>
    </p:spTree>
    <p:extLst>
      <p:ext uri="{BB962C8B-B14F-4D97-AF65-F5344CB8AC3E}">
        <p14:creationId xmlns:p14="http://schemas.microsoft.com/office/powerpoint/2010/main" val="37297046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e95f1b23-abaf-45ee-821d-b7ab251ab3bf}" enabled="0" method="" siteId="{e95f1b23-abaf-45ee-821d-b7ab251ab3bf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58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en, Qun   RICVAMC</dc:creator>
  <cp:lastModifiedBy>Chen, Qun   RICVAMC</cp:lastModifiedBy>
  <cp:revision>1</cp:revision>
  <dcterms:created xsi:type="dcterms:W3CDTF">2026-04-23T14:53:49Z</dcterms:created>
  <dcterms:modified xsi:type="dcterms:W3CDTF">2026-04-23T15:07:47Z</dcterms:modified>
</cp:coreProperties>
</file>